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154" userDrawn="1">
          <p15:clr>
            <a:srgbClr val="A4A3A4"/>
          </p15:clr>
        </p15:guide>
        <p15:guide id="3" pos="4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89" autoAdjust="0"/>
    <p:restoredTop sz="95982" autoAdjust="0"/>
  </p:normalViewPr>
  <p:slideViewPr>
    <p:cSldViewPr showGuides="1">
      <p:cViewPr varScale="1">
        <p:scale>
          <a:sx n="97" d="100"/>
          <a:sy n="97" d="100"/>
        </p:scale>
        <p:origin x="2904" y="96"/>
      </p:cViewPr>
      <p:guideLst>
        <p:guide orient="horz" pos="2880"/>
        <p:guide pos="3154"/>
        <p:guide pos="436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30740;&#31350;\&#35542;&#25991;\Butanol&#21069;&#20966;&#29702;\&#26032;&#22855;&#21069;&#20966;&#29702;_NREL&#27861;_&#31958;&#21270;-1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30740;&#31350;\&#35542;&#25991;\Butanol&#21069;&#20966;&#29702;\&#26032;&#22855;&#21069;&#20966;&#29702;_NREL&#27861;_&#31958;&#21270;-1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30740;&#31350;\&#35542;&#25991;\Butanol&#21069;&#20966;&#29702;\&#26032;&#22855;&#21069;&#20966;&#29702;_NREL&#27861;_&#31958;&#21270;-1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Solid fraction xylose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G$122:$G$127</c:f>
                <c:numCache>
                  <c:formatCode>General</c:formatCode>
                  <c:ptCount val="6"/>
                  <c:pt idx="0">
                    <c:v>6.4883869140021116E-2</c:v>
                  </c:pt>
                  <c:pt idx="1">
                    <c:v>0.94928956607226511</c:v>
                  </c:pt>
                  <c:pt idx="2">
                    <c:v>0.2508726945098253</c:v>
                  </c:pt>
                  <c:pt idx="3">
                    <c:v>0.90838314422621713</c:v>
                  </c:pt>
                  <c:pt idx="4">
                    <c:v>0.86163044677682354</c:v>
                  </c:pt>
                  <c:pt idx="5">
                    <c:v>0.13782697062616045</c:v>
                  </c:pt>
                </c:numCache>
              </c:numRef>
            </c:plus>
            <c:minus>
              <c:numRef>
                <c:f>lignin!$G$122:$G$127</c:f>
                <c:numCache>
                  <c:formatCode>General</c:formatCode>
                  <c:ptCount val="6"/>
                  <c:pt idx="0">
                    <c:v>6.4883869140021116E-2</c:v>
                  </c:pt>
                  <c:pt idx="1">
                    <c:v>0.94928956607226511</c:v>
                  </c:pt>
                  <c:pt idx="2">
                    <c:v>0.2508726945098253</c:v>
                  </c:pt>
                  <c:pt idx="3">
                    <c:v>0.90838314422621713</c:v>
                  </c:pt>
                  <c:pt idx="4">
                    <c:v>0.86163044677682354</c:v>
                  </c:pt>
                  <c:pt idx="5">
                    <c:v>0.13782697062616045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F$122:$F$127</c:f>
              <c:numCache>
                <c:formatCode>General</c:formatCode>
                <c:ptCount val="6"/>
                <c:pt idx="0">
                  <c:v>6.3688295420489327</c:v>
                </c:pt>
                <c:pt idx="1">
                  <c:v>7.9317470562451673</c:v>
                </c:pt>
                <c:pt idx="2">
                  <c:v>5.8469247978700167</c:v>
                </c:pt>
                <c:pt idx="3">
                  <c:v>6.9437172948001367</c:v>
                </c:pt>
                <c:pt idx="4">
                  <c:v>7.6720388339185845</c:v>
                </c:pt>
                <c:pt idx="5">
                  <c:v>6.2506610517577288</c:v>
                </c:pt>
              </c:numCache>
            </c:numRef>
          </c:val>
        </c:ser>
        <c:ser>
          <c:idx val="1"/>
          <c:order val="1"/>
          <c:tx>
            <c:v>Liquid farction xylose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I$90:$I$95</c:f>
                <c:numCache>
                  <c:formatCode>General</c:formatCode>
                  <c:ptCount val="6"/>
                  <c:pt idx="0">
                    <c:v>0.18245127083871643</c:v>
                  </c:pt>
                  <c:pt idx="1">
                    <c:v>0.68613872174349844</c:v>
                  </c:pt>
                  <c:pt idx="2">
                    <c:v>0.61151323918185074</c:v>
                  </c:pt>
                  <c:pt idx="3">
                    <c:v>0.1572972979735093</c:v>
                  </c:pt>
                  <c:pt idx="4">
                    <c:v>0.30829115822752012</c:v>
                  </c:pt>
                  <c:pt idx="5">
                    <c:v>7.2091594314216301E-2</c:v>
                  </c:pt>
                </c:numCache>
              </c:numRef>
            </c:plus>
            <c:minus>
              <c:numRef>
                <c:f>lignin!$I$90:$I$95</c:f>
                <c:numCache>
                  <c:formatCode>General</c:formatCode>
                  <c:ptCount val="6"/>
                  <c:pt idx="0">
                    <c:v>0.18245127083871643</c:v>
                  </c:pt>
                  <c:pt idx="1">
                    <c:v>0.68613872174349844</c:v>
                  </c:pt>
                  <c:pt idx="2">
                    <c:v>0.61151323918185074</c:v>
                  </c:pt>
                  <c:pt idx="3">
                    <c:v>0.1572972979735093</c:v>
                  </c:pt>
                  <c:pt idx="4">
                    <c:v>0.30829115822752012</c:v>
                  </c:pt>
                  <c:pt idx="5">
                    <c:v>7.2091594314216301E-2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H$122:$H$127</c:f>
              <c:numCache>
                <c:formatCode>General</c:formatCode>
                <c:ptCount val="6"/>
                <c:pt idx="0">
                  <c:v>90.753924588747992</c:v>
                </c:pt>
                <c:pt idx="1">
                  <c:v>93.827261233974397</c:v>
                </c:pt>
                <c:pt idx="2">
                  <c:v>97.411802887331433</c:v>
                </c:pt>
                <c:pt idx="3">
                  <c:v>85.831316595269371</c:v>
                </c:pt>
                <c:pt idx="4">
                  <c:v>79.263644897397938</c:v>
                </c:pt>
                <c:pt idx="5">
                  <c:v>90.635658476521357</c:v>
                </c:pt>
              </c:numCache>
            </c:numRef>
          </c:val>
        </c:ser>
        <c:ser>
          <c:idx val="2"/>
          <c:order val="2"/>
          <c:tx>
            <c:v>Liquid fraction furfural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K$90:$K$95</c:f>
                <c:numCache>
                  <c:formatCode>General</c:formatCode>
                  <c:ptCount val="6"/>
                  <c:pt idx="0">
                    <c:v>0.12852768542239112</c:v>
                  </c:pt>
                  <c:pt idx="1">
                    <c:v>0.12939993789795862</c:v>
                  </c:pt>
                  <c:pt idx="2">
                    <c:v>0.10978101490730402</c:v>
                  </c:pt>
                  <c:pt idx="3">
                    <c:v>0.12327499339243463</c:v>
                  </c:pt>
                  <c:pt idx="4">
                    <c:v>6.5630972895666537E-2</c:v>
                  </c:pt>
                  <c:pt idx="5">
                    <c:v>4.0165629280356448E-2</c:v>
                  </c:pt>
                </c:numCache>
              </c:numRef>
            </c:plus>
            <c:minus>
              <c:numRef>
                <c:f>lignin!$K$90:$K$95</c:f>
                <c:numCache>
                  <c:formatCode>General</c:formatCode>
                  <c:ptCount val="6"/>
                  <c:pt idx="0">
                    <c:v>0.12852768542239112</c:v>
                  </c:pt>
                  <c:pt idx="1">
                    <c:v>0.12939993789795862</c:v>
                  </c:pt>
                  <c:pt idx="2">
                    <c:v>0.10978101490730402</c:v>
                  </c:pt>
                  <c:pt idx="3">
                    <c:v>0.12327499339243463</c:v>
                  </c:pt>
                  <c:pt idx="4">
                    <c:v>6.5630972895666537E-2</c:v>
                  </c:pt>
                  <c:pt idx="5">
                    <c:v>4.0165629280356448E-2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J$122:$J$127</c:f>
              <c:numCache>
                <c:formatCode>General</c:formatCode>
                <c:ptCount val="6"/>
                <c:pt idx="0">
                  <c:v>6.1559425030972879</c:v>
                </c:pt>
                <c:pt idx="1">
                  <c:v>3.3894856501778445</c:v>
                </c:pt>
                <c:pt idx="2">
                  <c:v>2.8960835439751293</c:v>
                </c:pt>
                <c:pt idx="3">
                  <c:v>3.1468497675883591</c:v>
                </c:pt>
                <c:pt idx="4">
                  <c:v>2.6718591881948686</c:v>
                </c:pt>
                <c:pt idx="5">
                  <c:v>3.3371890156299799</c:v>
                </c:pt>
              </c:numCache>
            </c:numRef>
          </c:val>
        </c:ser>
        <c:ser>
          <c:idx val="3"/>
          <c:order val="3"/>
          <c:tx>
            <c:v>Organo solvent Furfural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M$90:$M$9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61615600962643313</c:v>
                  </c:pt>
                  <c:pt idx="5">
                    <c:v>0.73376948655130014</c:v>
                  </c:pt>
                </c:numCache>
              </c:numRef>
            </c:plus>
            <c:minus>
              <c:numRef>
                <c:f>lignin!$M$90:$M$9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61615600962643313</c:v>
                  </c:pt>
                  <c:pt idx="5">
                    <c:v>0.73376948655130014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L$122:$L$12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5380838156222276</c:v>
                </c:pt>
                <c:pt idx="5">
                  <c:v>1.8890467809186871</c:v>
                </c:pt>
              </c:numCache>
            </c:numRef>
          </c:val>
        </c:ser>
        <c:ser>
          <c:idx val="4"/>
          <c:order val="4"/>
          <c:tx>
            <c:v>Unknown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O$122:$O$127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.0781163423421329</c:v>
                </c:pt>
                <c:pt idx="4">
                  <c:v>8.8543732648663873</c:v>
                </c:pt>
                <c:pt idx="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300583888"/>
        <c:axId val="-300594224"/>
      </c:barChart>
      <c:catAx>
        <c:axId val="-300583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300594224"/>
        <c:crosses val="autoZero"/>
        <c:auto val="1"/>
        <c:lblAlgn val="ctr"/>
        <c:lblOffset val="100"/>
        <c:noMultiLvlLbl val="0"/>
      </c:catAx>
      <c:valAx>
        <c:axId val="-300594224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Xylose recovery (%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30058388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lignin!$G$159</c:f>
              <c:strCache>
                <c:ptCount val="1"/>
                <c:pt idx="0">
                  <c:v>Solid frac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H$161:$H$166</c:f>
                <c:numCache>
                  <c:formatCode>General</c:formatCode>
                  <c:ptCount val="6"/>
                  <c:pt idx="0">
                    <c:v>1.9724908571229365</c:v>
                  </c:pt>
                  <c:pt idx="1">
                    <c:v>0.45859366363289217</c:v>
                  </c:pt>
                  <c:pt idx="2">
                    <c:v>0.54890981714512932</c:v>
                  </c:pt>
                  <c:pt idx="3">
                    <c:v>5.7414622830717583</c:v>
                  </c:pt>
                  <c:pt idx="4">
                    <c:v>1.9298174133701194</c:v>
                  </c:pt>
                  <c:pt idx="5">
                    <c:v>0.92227065969917033</c:v>
                  </c:pt>
                </c:numCache>
              </c:numRef>
            </c:plus>
            <c:minus>
              <c:numRef>
                <c:f>lignin!$H$161:$H$166</c:f>
                <c:numCache>
                  <c:formatCode>General</c:formatCode>
                  <c:ptCount val="6"/>
                  <c:pt idx="0">
                    <c:v>1.9724908571229365</c:v>
                  </c:pt>
                  <c:pt idx="1">
                    <c:v>0.45859366363289217</c:v>
                  </c:pt>
                  <c:pt idx="2">
                    <c:v>0.54890981714512932</c:v>
                  </c:pt>
                  <c:pt idx="3">
                    <c:v>5.7414622830717583</c:v>
                  </c:pt>
                  <c:pt idx="4">
                    <c:v>1.9298174133701194</c:v>
                  </c:pt>
                  <c:pt idx="5">
                    <c:v>0.92227065969917033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G$161:$G$166</c:f>
              <c:numCache>
                <c:formatCode>General</c:formatCode>
                <c:ptCount val="6"/>
                <c:pt idx="0">
                  <c:v>52.836833823307103</c:v>
                </c:pt>
                <c:pt idx="1">
                  <c:v>50.342220714608288</c:v>
                </c:pt>
                <c:pt idx="2">
                  <c:v>50.817185379917738</c:v>
                </c:pt>
                <c:pt idx="3">
                  <c:v>55.889609245439807</c:v>
                </c:pt>
                <c:pt idx="4">
                  <c:v>35.323460820894724</c:v>
                </c:pt>
                <c:pt idx="5">
                  <c:v>25.674431582617217</c:v>
                </c:pt>
              </c:numCache>
            </c:numRef>
          </c:val>
        </c:ser>
        <c:ser>
          <c:idx val="2"/>
          <c:order val="1"/>
          <c:tx>
            <c:v>light liquor 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N$176:$N$181</c:f>
                <c:numCache>
                  <c:formatCode>General</c:formatCode>
                  <c:ptCount val="6"/>
                  <c:pt idx="0">
                    <c:v>0.80208639663447578</c:v>
                  </c:pt>
                  <c:pt idx="1">
                    <c:v>1.2223535618260597</c:v>
                  </c:pt>
                  <c:pt idx="2">
                    <c:v>1.4336195548371558</c:v>
                  </c:pt>
                  <c:pt idx="3">
                    <c:v>1.1135129361569902</c:v>
                  </c:pt>
                  <c:pt idx="4">
                    <c:v>0.47633770984267304</c:v>
                  </c:pt>
                  <c:pt idx="5">
                    <c:v>0.38311554690625105</c:v>
                  </c:pt>
                </c:numCache>
              </c:numRef>
            </c:plus>
            <c:minus>
              <c:numRef>
                <c:f>lignin!$N$176:$N$180</c:f>
                <c:numCache>
                  <c:formatCode>General</c:formatCode>
                  <c:ptCount val="5"/>
                  <c:pt idx="0">
                    <c:v>0.80208639663447578</c:v>
                  </c:pt>
                  <c:pt idx="1">
                    <c:v>1.2223535618260597</c:v>
                  </c:pt>
                  <c:pt idx="2">
                    <c:v>1.4336195548371558</c:v>
                  </c:pt>
                  <c:pt idx="3">
                    <c:v>1.1135129361569902</c:v>
                  </c:pt>
                  <c:pt idx="4">
                    <c:v>0.47633770984267304</c:v>
                  </c:pt>
                </c:numCache>
              </c:numRef>
            </c:minus>
          </c:errBars>
          <c:val>
            <c:numRef>
              <c:f>lignin!$M$176:$M$181</c:f>
              <c:numCache>
                <c:formatCode>General</c:formatCode>
                <c:ptCount val="6"/>
                <c:pt idx="0">
                  <c:v>5.7259158751695507</c:v>
                </c:pt>
                <c:pt idx="1">
                  <c:v>7.1743554952509472</c:v>
                </c:pt>
                <c:pt idx="2">
                  <c:v>9.3792401628221604</c:v>
                </c:pt>
                <c:pt idx="3">
                  <c:v>7.8052917232020942</c:v>
                </c:pt>
                <c:pt idx="4">
                  <c:v>4.2493554952509767</c:v>
                </c:pt>
                <c:pt idx="5">
                  <c:v>4.96415366350063</c:v>
                </c:pt>
              </c:numCache>
            </c:numRef>
          </c:val>
        </c:ser>
        <c:ser>
          <c:idx val="1"/>
          <c:order val="2"/>
          <c:tx>
            <c:strRef>
              <c:f>lignin!$I$159</c:f>
              <c:strCache>
                <c:ptCount val="1"/>
                <c:pt idx="0">
                  <c:v>Black liqu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J$161:$J$16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3270701580396396</c:v>
                  </c:pt>
                  <c:pt idx="5">
                    <c:v>1.6827112892491856</c:v>
                  </c:pt>
                </c:numCache>
              </c:numRef>
            </c:plus>
            <c:minus>
              <c:numRef>
                <c:f>lignin!$J$161:$J$16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3270701580396396</c:v>
                  </c:pt>
                  <c:pt idx="5">
                    <c:v>1.6827112892491856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I$161:$I$16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8.1040111940297894</c:v>
                </c:pt>
                <c:pt idx="5">
                  <c:v>19.062913415874995</c:v>
                </c:pt>
              </c:numCache>
            </c:numRef>
          </c:val>
        </c:ser>
        <c:ser>
          <c:idx val="3"/>
          <c:order val="3"/>
          <c:tx>
            <c:v>Unknown</c:v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val>
            <c:numRef>
              <c:f>lignin!$N$161:$N$166</c:f>
              <c:numCache>
                <c:formatCode>General</c:formatCode>
                <c:ptCount val="6"/>
                <c:pt idx="0">
                  <c:v>41.437250301523349</c:v>
                </c:pt>
                <c:pt idx="1">
                  <c:v>42.483423790140762</c:v>
                </c:pt>
                <c:pt idx="2">
                  <c:v>39.803574457260098</c:v>
                </c:pt>
                <c:pt idx="3">
                  <c:v>36.305099031358097</c:v>
                </c:pt>
                <c:pt idx="4">
                  <c:v>52.323172489824515</c:v>
                </c:pt>
                <c:pt idx="5">
                  <c:v>50.2985013380071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300592048"/>
        <c:axId val="-299319648"/>
      </c:barChart>
      <c:catAx>
        <c:axId val="-30059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299319648"/>
        <c:crosses val="autoZero"/>
        <c:auto val="1"/>
        <c:lblAlgn val="ctr"/>
        <c:lblOffset val="100"/>
        <c:noMultiLvlLbl val="0"/>
      </c:catAx>
      <c:valAx>
        <c:axId val="-299319648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Lignin recovery (%)</a:t>
                </a:r>
                <a:endParaRPr lang="ja-JP" b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-30059204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Solid fractio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G$90:$G$95</c:f>
                <c:numCache>
                  <c:formatCode>General</c:formatCode>
                  <c:ptCount val="6"/>
                  <c:pt idx="0">
                    <c:v>2.2063237451140019</c:v>
                  </c:pt>
                  <c:pt idx="1">
                    <c:v>7.1651257057482249</c:v>
                  </c:pt>
                  <c:pt idx="2">
                    <c:v>5.5742336976033906</c:v>
                  </c:pt>
                  <c:pt idx="3">
                    <c:v>2.0946776504471565</c:v>
                  </c:pt>
                  <c:pt idx="4">
                    <c:v>2.9268665193732768</c:v>
                  </c:pt>
                  <c:pt idx="5">
                    <c:v>1.7738843195294272</c:v>
                  </c:pt>
                </c:numCache>
              </c:numRef>
            </c:plus>
            <c:minus>
              <c:numRef>
                <c:f>lignin!$G$90:$G$95</c:f>
                <c:numCache>
                  <c:formatCode>General</c:formatCode>
                  <c:ptCount val="6"/>
                  <c:pt idx="0">
                    <c:v>2.2063237451140019</c:v>
                  </c:pt>
                  <c:pt idx="1">
                    <c:v>7.1651257057482249</c:v>
                  </c:pt>
                  <c:pt idx="2">
                    <c:v>5.5742336976033906</c:v>
                  </c:pt>
                  <c:pt idx="3">
                    <c:v>2.0946776504471565</c:v>
                  </c:pt>
                  <c:pt idx="4">
                    <c:v>2.9268665193732768</c:v>
                  </c:pt>
                  <c:pt idx="5">
                    <c:v>1.7738843195294272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F$90:$F$95</c:f>
              <c:numCache>
                <c:formatCode>General</c:formatCode>
                <c:ptCount val="6"/>
                <c:pt idx="0">
                  <c:v>91.104187195726922</c:v>
                </c:pt>
                <c:pt idx="1">
                  <c:v>86.187122490899654</c:v>
                </c:pt>
                <c:pt idx="2">
                  <c:v>85.886769650965505</c:v>
                </c:pt>
                <c:pt idx="3">
                  <c:v>86.136603626077672</c:v>
                </c:pt>
                <c:pt idx="4">
                  <c:v>84.375376618215213</c:v>
                </c:pt>
                <c:pt idx="5">
                  <c:v>71.915565278376761</c:v>
                </c:pt>
              </c:numCache>
            </c:numRef>
          </c:val>
        </c:ser>
        <c:ser>
          <c:idx val="1"/>
          <c:order val="1"/>
          <c:tx>
            <c:v>Liquid fraction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I$90:$I$95</c:f>
                <c:numCache>
                  <c:formatCode>General</c:formatCode>
                  <c:ptCount val="6"/>
                  <c:pt idx="0">
                    <c:v>0.18245127083871643</c:v>
                  </c:pt>
                  <c:pt idx="1">
                    <c:v>0.68613872174349844</c:v>
                  </c:pt>
                  <c:pt idx="2">
                    <c:v>0.61151323918185074</c:v>
                  </c:pt>
                  <c:pt idx="3">
                    <c:v>0.1572972979735093</c:v>
                  </c:pt>
                  <c:pt idx="4">
                    <c:v>0.30829115822752012</c:v>
                  </c:pt>
                  <c:pt idx="5">
                    <c:v>7.2091594314216301E-2</c:v>
                  </c:pt>
                </c:numCache>
              </c:numRef>
            </c:plus>
            <c:minus>
              <c:numRef>
                <c:f>lignin!$I$90:$I$95</c:f>
                <c:numCache>
                  <c:formatCode>General</c:formatCode>
                  <c:ptCount val="6"/>
                  <c:pt idx="0">
                    <c:v>0.18245127083871643</c:v>
                  </c:pt>
                  <c:pt idx="1">
                    <c:v>0.68613872174349844</c:v>
                  </c:pt>
                  <c:pt idx="2">
                    <c:v>0.61151323918185074</c:v>
                  </c:pt>
                  <c:pt idx="3">
                    <c:v>0.1572972979735093</c:v>
                  </c:pt>
                  <c:pt idx="4">
                    <c:v>0.30829115822752012</c:v>
                  </c:pt>
                  <c:pt idx="5">
                    <c:v>7.2091594314216301E-2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H$90:$H$95</c:f>
              <c:numCache>
                <c:formatCode>General</c:formatCode>
                <c:ptCount val="6"/>
                <c:pt idx="0">
                  <c:v>14.343801746242063</c:v>
                </c:pt>
                <c:pt idx="1">
                  <c:v>10.505219301728182</c:v>
                </c:pt>
                <c:pt idx="2">
                  <c:v>4.2901228213556477</c:v>
                </c:pt>
                <c:pt idx="3">
                  <c:v>3.6831951379603738</c:v>
                </c:pt>
                <c:pt idx="4">
                  <c:v>3.5252139817077124</c:v>
                </c:pt>
                <c:pt idx="5">
                  <c:v>3.7394129221061978</c:v>
                </c:pt>
              </c:numCache>
            </c:numRef>
          </c:val>
        </c:ser>
        <c:ser>
          <c:idx val="2"/>
          <c:order val="2"/>
          <c:tx>
            <c:v>Liquid fraction byproduct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K$90:$K$95</c:f>
                <c:numCache>
                  <c:formatCode>General</c:formatCode>
                  <c:ptCount val="6"/>
                  <c:pt idx="0">
                    <c:v>0.12852768542239112</c:v>
                  </c:pt>
                  <c:pt idx="1">
                    <c:v>0.12939993789795862</c:v>
                  </c:pt>
                  <c:pt idx="2">
                    <c:v>0.10978101490730402</c:v>
                  </c:pt>
                  <c:pt idx="3">
                    <c:v>0.12327499339243463</c:v>
                  </c:pt>
                  <c:pt idx="4">
                    <c:v>6.5630972895666537E-2</c:v>
                  </c:pt>
                  <c:pt idx="5">
                    <c:v>4.0165629280356448E-2</c:v>
                  </c:pt>
                </c:numCache>
              </c:numRef>
            </c:plus>
            <c:minus>
              <c:numRef>
                <c:f>lignin!$K$90:$K$95</c:f>
                <c:numCache>
                  <c:formatCode>General</c:formatCode>
                  <c:ptCount val="6"/>
                  <c:pt idx="0">
                    <c:v>0.12852768542239112</c:v>
                  </c:pt>
                  <c:pt idx="1">
                    <c:v>0.12939993789795862</c:v>
                  </c:pt>
                  <c:pt idx="2">
                    <c:v>0.10978101490730402</c:v>
                  </c:pt>
                  <c:pt idx="3">
                    <c:v>0.12327499339243463</c:v>
                  </c:pt>
                  <c:pt idx="4">
                    <c:v>6.5630972895666537E-2</c:v>
                  </c:pt>
                  <c:pt idx="5">
                    <c:v>4.0165629280356448E-2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J$90:$J$95</c:f>
              <c:numCache>
                <c:formatCode>General</c:formatCode>
                <c:ptCount val="6"/>
                <c:pt idx="0">
                  <c:v>0.75579938496223309</c:v>
                </c:pt>
                <c:pt idx="1">
                  <c:v>0.54560129336524299</c:v>
                </c:pt>
                <c:pt idx="2">
                  <c:v>0.58626159854360638</c:v>
                </c:pt>
                <c:pt idx="3">
                  <c:v>0.5408653394183347</c:v>
                </c:pt>
                <c:pt idx="4">
                  <c:v>0.51394431758637238</c:v>
                </c:pt>
                <c:pt idx="5">
                  <c:v>0.55989774530495651</c:v>
                </c:pt>
              </c:numCache>
            </c:numRef>
          </c:val>
        </c:ser>
        <c:ser>
          <c:idx val="3"/>
          <c:order val="3"/>
          <c:tx>
            <c:strRef>
              <c:f>lignin!$L$100</c:f>
              <c:strCache>
                <c:ptCount val="1"/>
                <c:pt idx="0">
                  <c:v>Black liqu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ignin!$M$90:$M$9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61615600962643313</c:v>
                  </c:pt>
                  <c:pt idx="5">
                    <c:v>0.73376948655130014</c:v>
                  </c:pt>
                </c:numCache>
              </c:numRef>
            </c:plus>
            <c:minus>
              <c:numRef>
                <c:f>lignin!$M$90:$M$9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61615600962643313</c:v>
                  </c:pt>
                  <c:pt idx="5">
                    <c:v>0.73376948655130014</c:v>
                  </c:pt>
                </c:numCache>
              </c:numRef>
            </c:minus>
          </c:errBars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L$90:$L$95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5380838156222276</c:v>
                </c:pt>
                <c:pt idx="5">
                  <c:v>1.8890467809186871</c:v>
                </c:pt>
              </c:numCache>
            </c:numRef>
          </c:val>
        </c:ser>
        <c:ser>
          <c:idx val="4"/>
          <c:order val="4"/>
          <c:tx>
            <c:v>Unknown</c:v>
          </c:tx>
          <c:spPr>
            <a:pattFill prst="pct20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strRef>
              <c:f>lignin!$E$100:$E$105</c:f>
              <c:strCache>
                <c:ptCount val="6"/>
                <c:pt idx="0">
                  <c:v>Control</c:v>
                </c:pt>
                <c:pt idx="1">
                  <c:v>Ethanol</c:v>
                </c:pt>
                <c:pt idx="2">
                  <c:v>1-propanol</c:v>
                </c:pt>
                <c:pt idx="3">
                  <c:v>2-propanol</c:v>
                </c:pt>
                <c:pt idx="4">
                  <c:v>1-butanol</c:v>
                </c:pt>
                <c:pt idx="5">
                  <c:v>1-pentanol</c:v>
                </c:pt>
              </c:strCache>
            </c:strRef>
          </c:cat>
          <c:val>
            <c:numRef>
              <c:f>lignin!$O$90:$O$95</c:f>
              <c:numCache>
                <c:formatCode>General</c:formatCode>
                <c:ptCount val="6"/>
                <c:pt idx="0">
                  <c:v>0</c:v>
                </c:pt>
                <c:pt idx="1">
                  <c:v>2.7620569140069211</c:v>
                </c:pt>
                <c:pt idx="2">
                  <c:v>9.2368459291352405</c:v>
                </c:pt>
                <c:pt idx="3">
                  <c:v>9.6393358965436189</c:v>
                </c:pt>
                <c:pt idx="4">
                  <c:v>10.047381266868475</c:v>
                </c:pt>
                <c:pt idx="5">
                  <c:v>21.89607727329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99325088"/>
        <c:axId val="-299323456"/>
      </c:barChart>
      <c:catAx>
        <c:axId val="-299325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299323456"/>
        <c:crosses val="autoZero"/>
        <c:auto val="1"/>
        <c:lblAlgn val="ctr"/>
        <c:lblOffset val="100"/>
        <c:noMultiLvlLbl val="0"/>
      </c:catAx>
      <c:valAx>
        <c:axId val="-299323456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lucose recovery (%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9932508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B54F9E-B317-470E-A6C0-1CD4130156B7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8A972A-3CEA-4486-8F38-43F2A1C8A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572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19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443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948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231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54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65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74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996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66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709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900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72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792992" y="8155511"/>
            <a:ext cx="35333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_file_1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TX</a:t>
            </a:r>
            <a:endParaRPr lang="en-US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5524780"/>
              </p:ext>
            </p:extLst>
          </p:nvPr>
        </p:nvGraphicFramePr>
        <p:xfrm>
          <a:off x="-1" y="3188425"/>
          <a:ext cx="5148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3398" y="74090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398" y="330779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810" y="566439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885203"/>
              </p:ext>
            </p:extLst>
          </p:nvPr>
        </p:nvGraphicFramePr>
        <p:xfrm>
          <a:off x="9879" y="5589233"/>
          <a:ext cx="5148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5234830"/>
              </p:ext>
            </p:extLst>
          </p:nvPr>
        </p:nvGraphicFramePr>
        <p:xfrm>
          <a:off x="-9264" y="755576"/>
          <a:ext cx="5148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" name="グループ化 3"/>
          <p:cNvGrpSpPr/>
          <p:nvPr/>
        </p:nvGrpSpPr>
        <p:grpSpPr>
          <a:xfrm>
            <a:off x="692150" y="374819"/>
            <a:ext cx="1066493" cy="276999"/>
            <a:chOff x="1975244" y="433315"/>
            <a:chExt cx="1066493" cy="276999"/>
          </a:xfrm>
        </p:grpSpPr>
        <p:sp>
          <p:nvSpPr>
            <p:cNvPr id="19" name="正方形/長方形 18"/>
            <p:cNvSpPr/>
            <p:nvPr/>
          </p:nvSpPr>
          <p:spPr>
            <a:xfrm>
              <a:off x="1975244" y="513402"/>
              <a:ext cx="116824" cy="116824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2012288" y="433315"/>
              <a:ext cx="10294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lid fractio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グループ化 24"/>
          <p:cNvGrpSpPr/>
          <p:nvPr/>
        </p:nvGrpSpPr>
        <p:grpSpPr>
          <a:xfrm>
            <a:off x="1873278" y="374819"/>
            <a:ext cx="1153055" cy="276999"/>
            <a:chOff x="1975244" y="433315"/>
            <a:chExt cx="1153055" cy="276999"/>
          </a:xfrm>
        </p:grpSpPr>
        <p:sp>
          <p:nvSpPr>
            <p:cNvPr id="26" name="正方形/長方形 25"/>
            <p:cNvSpPr/>
            <p:nvPr/>
          </p:nvSpPr>
          <p:spPr>
            <a:xfrm>
              <a:off x="1975244" y="513402"/>
              <a:ext cx="116824" cy="116824"/>
            </a:xfrm>
            <a:prstGeom prst="rect">
              <a:avLst/>
            </a:prstGeom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2012288" y="433315"/>
              <a:ext cx="11160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 fractio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グループ化 27"/>
          <p:cNvGrpSpPr/>
          <p:nvPr/>
        </p:nvGrpSpPr>
        <p:grpSpPr>
          <a:xfrm>
            <a:off x="3140968" y="374819"/>
            <a:ext cx="1816698" cy="276999"/>
            <a:chOff x="1975244" y="433315"/>
            <a:chExt cx="1816698" cy="276999"/>
          </a:xfrm>
        </p:grpSpPr>
        <p:sp>
          <p:nvSpPr>
            <p:cNvPr id="29" name="正方形/長方形 28"/>
            <p:cNvSpPr/>
            <p:nvPr/>
          </p:nvSpPr>
          <p:spPr>
            <a:xfrm>
              <a:off x="1975244" y="513402"/>
              <a:ext cx="116824" cy="116824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2012288" y="433315"/>
              <a:ext cx="17796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 fraction byproduct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グループ化 30"/>
          <p:cNvGrpSpPr/>
          <p:nvPr/>
        </p:nvGrpSpPr>
        <p:grpSpPr>
          <a:xfrm>
            <a:off x="692150" y="558665"/>
            <a:ext cx="989549" cy="276999"/>
            <a:chOff x="1975244" y="433315"/>
            <a:chExt cx="989549" cy="276999"/>
          </a:xfrm>
        </p:grpSpPr>
        <p:sp>
          <p:nvSpPr>
            <p:cNvPr id="32" name="正方形/長方形 31"/>
            <p:cNvSpPr/>
            <p:nvPr/>
          </p:nvSpPr>
          <p:spPr>
            <a:xfrm>
              <a:off x="1975244" y="513402"/>
              <a:ext cx="116824" cy="116824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2012288" y="433315"/>
              <a:ext cx="952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ck liquo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グループ化 33"/>
          <p:cNvGrpSpPr/>
          <p:nvPr/>
        </p:nvGrpSpPr>
        <p:grpSpPr>
          <a:xfrm>
            <a:off x="1873278" y="558665"/>
            <a:ext cx="823862" cy="276999"/>
            <a:chOff x="1975244" y="433315"/>
            <a:chExt cx="823862" cy="276999"/>
          </a:xfrm>
        </p:grpSpPr>
        <p:sp>
          <p:nvSpPr>
            <p:cNvPr id="35" name="正方形/長方形 34"/>
            <p:cNvSpPr/>
            <p:nvPr/>
          </p:nvSpPr>
          <p:spPr>
            <a:xfrm>
              <a:off x="1975244" y="513402"/>
              <a:ext cx="116824" cy="116824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2012288" y="433315"/>
              <a:ext cx="7868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know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86728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0</TotalTime>
  <Words>25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寺村浩</cp:lastModifiedBy>
  <cp:revision>49</cp:revision>
  <dcterms:created xsi:type="dcterms:W3CDTF">2015-11-18T01:14:49Z</dcterms:created>
  <dcterms:modified xsi:type="dcterms:W3CDTF">2015-12-16T07:48:28Z</dcterms:modified>
</cp:coreProperties>
</file>